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5493"/>
    <a:srgbClr val="39B882"/>
    <a:srgbClr val="343D52"/>
    <a:srgbClr val="485063"/>
    <a:srgbClr val="354F5F"/>
    <a:srgbClr val="152538"/>
    <a:srgbClr val="0C2D4C"/>
    <a:srgbClr val="2D3E55"/>
    <a:srgbClr val="011893"/>
    <a:srgbClr val="0048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738"/>
    <p:restoredTop sz="94694"/>
  </p:normalViewPr>
  <p:slideViewPr>
    <p:cSldViewPr snapToGrid="0" snapToObjects="1">
      <p:cViewPr>
        <p:scale>
          <a:sx n="124" d="100"/>
          <a:sy n="124" d="100"/>
        </p:scale>
        <p:origin x="776" y="-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B0934A-73F7-1F4D-8E48-3E4A6021BA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F5CDD2B-C91F-C94C-859A-713BFC4DD1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91ED89-A522-574C-BEF6-23952F3B4B57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7/2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6863A7-7AEA-9B47-919A-F8290FDF75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907878-B1BF-934B-B3EE-C0F2BF7722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39624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16CE03-BAB6-DF4C-8DDE-EDF8B40D5F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1739278-2F15-C545-AAAE-F43E2A6854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2E6775-CD32-3142-8FBA-CDFB263F3F2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7/2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61732B-9114-794D-A840-56608EFFA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87E824-670B-F54F-B320-0C9D58D344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006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A98D59E-1E91-6442-B486-69DCB6DED4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C48020-99DE-034A-896B-B168AFB238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B4BD8C-E04E-344D-BCA3-4A12AF9F9FD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7/2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22BA77-B54E-294B-8E51-618E05266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87FCA8-BA90-3541-B0B2-65F59CAACB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543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11FE32-5B64-E243-9843-A1EA2051C3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68202A-F2E5-FC45-ACF7-E80F6D7F88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4E0E2A-40A9-9E49-9929-3C392D31873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7/2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FC6A75-50A7-FD48-9F8D-FB2C39DA3A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3C649F-74CE-F84F-B801-BA6564F4E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93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C92EFB-E534-0B42-82B0-D66CA3A688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ED4610-C5DA-DD4F-87FA-011B5B738A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9B7977-8B5A-5F4D-A953-66956B975D5E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7/2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9D024F-74DA-F747-9F3F-12FC38574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B084D1-6F99-7B4A-86C4-626B3DBD42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964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EB8CA2-0484-E046-B109-39812C272F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398EB0-FE7C-194F-ADF9-152ECCB3958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031F7A-AE90-1B46-AE9B-15C84FAB35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1FA71C-8983-674C-A8D8-7A92D4E77443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7/27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CCBC2C-F5E8-8B44-AAF8-57C9F683B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138B94-9D6F-7649-A1CE-5DF2873EAA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4855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4A7FB-656F-2D44-BF6D-9A6296F5C5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ED082F-CF7B-6640-B0DD-47812C442D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7A971E-FD89-D045-859D-668111E877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97CA272-0B40-1C4C-8651-B6B649E82C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BA28564-A83D-3D41-9326-EE04008E1C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26F9878-94A7-D440-9A77-51A1EA8F785D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7/27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13572D8-65D0-A74D-9157-DA78839BAC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367A03D-FD78-174E-A057-4CDF5DE3C8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5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B3D4D0-427F-3644-AE9F-7F9F02C8FE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A6876D9-D8F4-3E46-AD79-3F1CA5075968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7/27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D88B33-B404-7D49-8C6E-72E7BEE54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4BF84DA-594E-BF46-A0F9-E98ECA299D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203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C642915-FDC1-FB40-B2EA-C81621B13A4E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7/27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1282C27-207A-D143-B2F5-5ACDD3A0A9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363BDB4-97C0-664F-82A9-FDEED8DC8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0744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B6FD49-22F7-6342-8EB6-58DC854D98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738B74-02DD-4E41-B862-2E393D02CC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763CE6A-13AB-674E-94BC-02C05CBD26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D367F2-1863-8745-B0C0-223C48254926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7/27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2BA1F2-4205-3B42-9CA2-608CF7CB1D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671325-42DD-9D4C-BA1C-C3F3E0481E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9970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737B78-070F-F345-B4F5-2CD85DB00F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3A062D-BBBC-9E4F-BB12-301E15D789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B13057-E866-B245-8719-C8F338C3C0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D9CA1E-011F-874B-B115-68686FE8F4EC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7/27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22A0C4-99AA-1345-9159-65D57E98C6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17377B-6239-5143-A68F-90A23176B5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895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5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844040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svg"/><Relationship Id="rId5" Type="http://schemas.openxmlformats.org/officeDocument/2006/relationships/image" Target="../media/image4.png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F0DEE156-89C7-FF43-991B-3DD24BD32D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-25894"/>
            <a:ext cx="12192000" cy="707886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F548E9D6-92B2-D44D-BBCE-51953A30C681}"/>
              </a:ext>
            </a:extLst>
          </p:cNvPr>
          <p:cNvSpPr/>
          <p:nvPr/>
        </p:nvSpPr>
        <p:spPr>
          <a:xfrm>
            <a:off x="0" y="683179"/>
            <a:ext cx="12192000" cy="231227"/>
          </a:xfrm>
          <a:prstGeom prst="rect">
            <a:avLst/>
          </a:prstGeom>
          <a:solidFill>
            <a:srgbClr val="343D52"/>
          </a:solidFill>
          <a:ln>
            <a:solidFill>
              <a:srgbClr val="354F5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dirty="0">
                <a:solidFill>
                  <a:schemeClr val="bg1"/>
                </a:solidFill>
              </a:rPr>
              <a:t>           @</a:t>
            </a:r>
            <a:r>
              <a:rPr lang="en-US" sz="1200" dirty="0" err="1">
                <a:solidFill>
                  <a:schemeClr val="bg1"/>
                </a:solidFill>
              </a:rPr>
              <a:t>TheTxIDJournal</a:t>
            </a:r>
            <a:r>
              <a:rPr lang="en-US" sz="1200" dirty="0">
                <a:solidFill>
                  <a:schemeClr val="bg1"/>
                </a:solidFill>
              </a:rPr>
              <a:t>  @</a:t>
            </a:r>
            <a:r>
              <a:rPr lang="en-US" sz="1200" dirty="0" err="1">
                <a:solidFill>
                  <a:schemeClr val="bg1"/>
                </a:solidFill>
              </a:rPr>
              <a:t>HannahImlay</a:t>
            </a:r>
            <a:endParaRPr lang="en-US" sz="1200" dirty="0">
              <a:solidFill>
                <a:schemeClr val="bg1"/>
              </a:solidFill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23CCF476-319F-8140-A593-7D3D0C061C4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4854" y="668975"/>
            <a:ext cx="276606" cy="276606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492131EC-6391-3144-8E00-5CE130B4CE5F}"/>
              </a:ext>
            </a:extLst>
          </p:cNvPr>
          <p:cNvSpPr txBox="1"/>
          <p:nvPr/>
        </p:nvSpPr>
        <p:spPr>
          <a:xfrm>
            <a:off x="8616989" y="660292"/>
            <a:ext cx="33335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Imlay </a:t>
            </a:r>
            <a:r>
              <a:rPr lang="en-US" sz="1200" i="1" dirty="0">
                <a:solidFill>
                  <a:schemeClr val="bg1"/>
                </a:solidFill>
              </a:rPr>
              <a:t>et al</a:t>
            </a:r>
            <a:r>
              <a:rPr lang="en-US" sz="1200" dirty="0">
                <a:solidFill>
                  <a:schemeClr val="bg1"/>
                </a:solidFill>
              </a:rPr>
              <a:t>.  </a:t>
            </a:r>
            <a:r>
              <a:rPr lang="en-US" sz="1200" b="1" i="1" dirty="0">
                <a:solidFill>
                  <a:schemeClr val="bg1"/>
                </a:solidFill>
              </a:rPr>
              <a:t>Transplant Infectious Diseases</a:t>
            </a:r>
            <a:r>
              <a:rPr lang="en-US" sz="1200" dirty="0">
                <a:solidFill>
                  <a:schemeClr val="bg1"/>
                </a:solidFill>
              </a:rPr>
              <a:t>.  2024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1A0D7E5-0BBB-AD44-B806-57C0B508F8D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6073352"/>
            <a:ext cx="12271830" cy="93620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7FD39CF-48BE-F043-9CA6-1EA6F45D25E8}"/>
              </a:ext>
            </a:extLst>
          </p:cNvPr>
          <p:cNvSpPr txBox="1"/>
          <p:nvPr/>
        </p:nvSpPr>
        <p:spPr>
          <a:xfrm>
            <a:off x="1274880" y="0"/>
            <a:ext cx="972206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 randomized, placebo-controlled, dose-escalation phase I/II multicenter trial of low-dose cidofovir for BK Polyomavirus Nephropathy (</a:t>
            </a:r>
            <a:r>
              <a:rPr lang="en-US" sz="1800" b="1" dirty="0" err="1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KPyVAN</a:t>
            </a:r>
            <a:r>
              <a:rPr lang="en-US" sz="1800" b="1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endParaRPr lang="en-US" sz="1800" dirty="0">
              <a:solidFill>
                <a:schemeClr val="bg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366636D0-BF84-4A1A-9E37-3446B179CF50}"/>
              </a:ext>
            </a:extLst>
          </p:cNvPr>
          <p:cNvCxnSpPr/>
          <p:nvPr/>
        </p:nvCxnSpPr>
        <p:spPr>
          <a:xfrm>
            <a:off x="0" y="639744"/>
            <a:ext cx="12192000" cy="0"/>
          </a:xfrm>
          <a:prstGeom prst="line">
            <a:avLst/>
          </a:prstGeom>
          <a:ln w="76200">
            <a:solidFill>
              <a:srgbClr val="39B88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" name="Graphic 5" descr="Kidneys with solid fill">
            <a:extLst>
              <a:ext uri="{FF2B5EF4-FFF2-40B4-BE49-F238E27FC236}">
                <a16:creationId xmlns:a16="http://schemas.microsoft.com/office/drawing/2014/main" id="{59CC46A8-CA4D-1F77-17B0-47ED366EA76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268659" y="2136717"/>
            <a:ext cx="1245103" cy="1245103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9EE62F0D-79CC-1ABC-5E1F-BD2218AAC172}"/>
              </a:ext>
            </a:extLst>
          </p:cNvPr>
          <p:cNvSpPr txBox="1"/>
          <p:nvPr/>
        </p:nvSpPr>
        <p:spPr>
          <a:xfrm>
            <a:off x="6151924" y="5389243"/>
            <a:ext cx="5895909" cy="646331"/>
          </a:xfrm>
          <a:prstGeom prst="rect">
            <a:avLst/>
          </a:prstGeom>
          <a:solidFill>
            <a:srgbClr val="005493"/>
          </a:solidFill>
          <a:ln w="28575">
            <a:solidFill>
              <a:srgbClr val="005493"/>
            </a:solidFill>
          </a:ln>
        </p:spPr>
        <p:txBody>
          <a:bodyPr wrap="square" rtlCol="0">
            <a:spAutoFit/>
          </a:bodyPr>
          <a:lstStyle/>
          <a:p>
            <a:r>
              <a:rPr lang="en-US" sz="18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nclusions: </a:t>
            </a:r>
            <a:r>
              <a:rPr lang="en-US" dirty="0">
                <a:solidFill>
                  <a:schemeClr val="bg1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at the doses studied, cidofovir was safe and tolerated but had no significant </a:t>
            </a:r>
            <a:r>
              <a:rPr lang="en-US" dirty="0" err="1">
                <a:solidFill>
                  <a:schemeClr val="bg1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BKPyV</a:t>
            </a:r>
            <a:r>
              <a:rPr lang="en-US" dirty="0">
                <a:solidFill>
                  <a:schemeClr val="bg1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-specific antiviral effec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6AD4A69-4958-AB69-A49C-31397723BBE1}"/>
              </a:ext>
            </a:extLst>
          </p:cNvPr>
          <p:cNvSpPr txBox="1"/>
          <p:nvPr/>
        </p:nvSpPr>
        <p:spPr>
          <a:xfrm>
            <a:off x="144167" y="1245614"/>
            <a:ext cx="5710095" cy="646331"/>
          </a:xfrm>
          <a:prstGeom prst="rect">
            <a:avLst/>
          </a:prstGeom>
          <a:solidFill>
            <a:srgbClr val="005493"/>
          </a:solidFill>
        </p:spPr>
        <p:txBody>
          <a:bodyPr wrap="square" rtlCol="0">
            <a:spAutoFit/>
          </a:bodyPr>
          <a:lstStyle/>
          <a:p>
            <a:r>
              <a:rPr lang="en-US" sz="18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bjective: </a:t>
            </a:r>
            <a:r>
              <a:rPr lang="en-US" dirty="0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amine </a:t>
            </a:r>
            <a:r>
              <a:rPr lang="en-US" b="1" dirty="0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afety</a:t>
            </a:r>
            <a:r>
              <a:rPr lang="en-US" dirty="0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US" b="1" dirty="0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fficacy</a:t>
            </a:r>
            <a:r>
              <a:rPr lang="en-US" dirty="0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low-dose cidofovir among kidney transplant recipients with </a:t>
            </a:r>
            <a:r>
              <a:rPr lang="en-US" dirty="0" err="1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KPyVAN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DF7DDB1-B36A-C50D-5C6C-F638A764501A}"/>
              </a:ext>
            </a:extLst>
          </p:cNvPr>
          <p:cNvSpPr txBox="1"/>
          <p:nvPr/>
        </p:nvSpPr>
        <p:spPr>
          <a:xfrm>
            <a:off x="6151924" y="1245614"/>
            <a:ext cx="5895909" cy="923330"/>
          </a:xfrm>
          <a:prstGeom prst="rect">
            <a:avLst/>
          </a:prstGeom>
          <a:noFill/>
          <a:ln w="28575">
            <a:solidFill>
              <a:srgbClr val="005493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Arial" panose="020B0604020202020204" pitchFamily="34" charset="0"/>
              </a:rPr>
              <a:t>Enrolled at eight U.S. centers: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latin typeface="Calibri" panose="020F0502020204030204" pitchFamily="34" charset="0"/>
                <a:cs typeface="Arial" panose="020B0604020202020204" pitchFamily="34" charset="0"/>
              </a:rPr>
              <a:t>22 kidney recipients with biopsy-confirmed </a:t>
            </a:r>
            <a:r>
              <a:rPr lang="en-US" dirty="0" err="1">
                <a:latin typeface="Calibri" panose="020F0502020204030204" pitchFamily="34" charset="0"/>
                <a:cs typeface="Arial" panose="020B0604020202020204" pitchFamily="34" charset="0"/>
              </a:rPr>
              <a:t>BKPyVAN</a:t>
            </a:r>
            <a:endParaRPr lang="en-US" dirty="0">
              <a:latin typeface="Calibri" panose="020F050202020403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latin typeface="Calibri" panose="020F0502020204030204" pitchFamily="34" charset="0"/>
                <a:cs typeface="Arial" panose="020B0604020202020204" pitchFamily="34" charset="0"/>
              </a:rPr>
              <a:t>Trial stopped prematurely for slow enrollment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7D87D1B-E560-2661-6DC0-ED0DCDD02991}"/>
              </a:ext>
            </a:extLst>
          </p:cNvPr>
          <p:cNvSpPr txBox="1"/>
          <p:nvPr/>
        </p:nvSpPr>
        <p:spPr>
          <a:xfrm>
            <a:off x="3694891" y="2141791"/>
            <a:ext cx="2174373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Eligibility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dirty="0"/>
              <a:t>Kidney or kidney-pancreas recipient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dirty="0"/>
              <a:t>Biopsy-confirmed or probable </a:t>
            </a:r>
            <a:r>
              <a:rPr lang="en-US" sz="1600" dirty="0" err="1"/>
              <a:t>BKPyVAN</a:t>
            </a:r>
            <a:endParaRPr lang="en-US" sz="1600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dirty="0" err="1"/>
              <a:t>BKPyV</a:t>
            </a:r>
            <a:r>
              <a:rPr lang="en-US" sz="1600" dirty="0"/>
              <a:t> load &gt;10,000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dirty="0"/>
              <a:t>eGFR ≥30 mL/min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4F9D8EB-FC0B-A19C-AFD8-BEBE5E04EE86}"/>
              </a:ext>
            </a:extLst>
          </p:cNvPr>
          <p:cNvSpPr txBox="1"/>
          <p:nvPr/>
        </p:nvSpPr>
        <p:spPr>
          <a:xfrm>
            <a:off x="1968931" y="4557263"/>
            <a:ext cx="175905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idofovir 0.25 mg/kg/dos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0CC5C26-C1D9-D5DE-171D-A34FDC5DA3E3}"/>
              </a:ext>
            </a:extLst>
          </p:cNvPr>
          <p:cNvSpPr txBox="1"/>
          <p:nvPr/>
        </p:nvSpPr>
        <p:spPr>
          <a:xfrm>
            <a:off x="3775217" y="4558248"/>
            <a:ext cx="14009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idofovir 0.5 mg/kg/dos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A1EB6B5-A649-8F0D-3BDB-F118FCEBB21E}"/>
              </a:ext>
            </a:extLst>
          </p:cNvPr>
          <p:cNvSpPr txBox="1"/>
          <p:nvPr/>
        </p:nvSpPr>
        <p:spPr>
          <a:xfrm>
            <a:off x="735731" y="4571562"/>
            <a:ext cx="1400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lacebo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8A2FC93-62B4-4742-5DCE-2AFC1C755367}"/>
              </a:ext>
            </a:extLst>
          </p:cNvPr>
          <p:cNvSpPr txBox="1"/>
          <p:nvPr/>
        </p:nvSpPr>
        <p:spPr>
          <a:xfrm>
            <a:off x="144167" y="5391360"/>
            <a:ext cx="5710095" cy="646331"/>
          </a:xfrm>
          <a:prstGeom prst="rect">
            <a:avLst/>
          </a:prstGeom>
          <a:noFill/>
          <a:ln w="28575">
            <a:solidFill>
              <a:srgbClr val="005493"/>
            </a:solidFill>
          </a:ln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udy drug administered on days 0, 7, 21, and 35, with final follow-up through day 49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13BAEEA4-263F-1AEB-A377-D0C25CC99F55}"/>
              </a:ext>
            </a:extLst>
          </p:cNvPr>
          <p:cNvCxnSpPr>
            <a:cxnSpLocks/>
          </p:cNvCxnSpPr>
          <p:nvPr/>
        </p:nvCxnSpPr>
        <p:spPr>
          <a:xfrm flipH="1">
            <a:off x="1697976" y="3750965"/>
            <a:ext cx="880306" cy="861366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7FFE30DD-40E5-C2EF-7021-3A9815DD613E}"/>
              </a:ext>
            </a:extLst>
          </p:cNvPr>
          <p:cNvCxnSpPr>
            <a:cxnSpLocks/>
          </p:cNvCxnSpPr>
          <p:nvPr/>
        </p:nvCxnSpPr>
        <p:spPr>
          <a:xfrm>
            <a:off x="3158150" y="3746624"/>
            <a:ext cx="890731" cy="789855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3975758D-C838-1B74-4E8B-2FC3B6A19D51}"/>
              </a:ext>
            </a:extLst>
          </p:cNvPr>
          <p:cNvCxnSpPr>
            <a:cxnSpLocks/>
            <a:stCxn id="37" idx="2"/>
          </p:cNvCxnSpPr>
          <p:nvPr/>
        </p:nvCxnSpPr>
        <p:spPr>
          <a:xfrm flipH="1">
            <a:off x="2848457" y="3758249"/>
            <a:ext cx="8458" cy="78874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5ED67C37-9DC4-8AF5-ADB0-08058D7FC1CB}"/>
              </a:ext>
            </a:extLst>
          </p:cNvPr>
          <p:cNvSpPr txBox="1"/>
          <p:nvPr/>
        </p:nvSpPr>
        <p:spPr>
          <a:xfrm>
            <a:off x="2152722" y="3388917"/>
            <a:ext cx="1408386" cy="369332"/>
          </a:xfrm>
          <a:prstGeom prst="rect">
            <a:avLst/>
          </a:prstGeom>
          <a:solidFill>
            <a:srgbClr val="39B882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Randomized</a:t>
            </a:r>
          </a:p>
        </p:txBody>
      </p:sp>
      <p:graphicFrame>
        <p:nvGraphicFramePr>
          <p:cNvPr id="41" name="Table 40">
            <a:extLst>
              <a:ext uri="{FF2B5EF4-FFF2-40B4-BE49-F238E27FC236}">
                <a16:creationId xmlns:a16="http://schemas.microsoft.com/office/drawing/2014/main" id="{97F570A2-3503-8E83-55D7-E896A640196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4000648"/>
              </p:ext>
            </p:extLst>
          </p:nvPr>
        </p:nvGraphicFramePr>
        <p:xfrm>
          <a:off x="6508705" y="2369678"/>
          <a:ext cx="5315884" cy="27787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039394">
                  <a:extLst>
                    <a:ext uri="{9D8B030D-6E8A-4147-A177-3AD203B41FA5}">
                      <a16:colId xmlns:a16="http://schemas.microsoft.com/office/drawing/2014/main" val="1816841709"/>
                    </a:ext>
                  </a:extLst>
                </a:gridCol>
                <a:gridCol w="1127735">
                  <a:extLst>
                    <a:ext uri="{9D8B030D-6E8A-4147-A177-3AD203B41FA5}">
                      <a16:colId xmlns:a16="http://schemas.microsoft.com/office/drawing/2014/main" val="4112592291"/>
                    </a:ext>
                  </a:extLst>
                </a:gridCol>
                <a:gridCol w="1075942">
                  <a:extLst>
                    <a:ext uri="{9D8B030D-6E8A-4147-A177-3AD203B41FA5}">
                      <a16:colId xmlns:a16="http://schemas.microsoft.com/office/drawing/2014/main" val="3004307249"/>
                    </a:ext>
                  </a:extLst>
                </a:gridCol>
                <a:gridCol w="1072813">
                  <a:extLst>
                    <a:ext uri="{9D8B030D-6E8A-4147-A177-3AD203B41FA5}">
                      <a16:colId xmlns:a16="http://schemas.microsoft.com/office/drawing/2014/main" val="1160249202"/>
                    </a:ext>
                  </a:extLst>
                </a:gridCol>
              </a:tblGrid>
              <a:tr h="493640"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solidFill>
                          <a:schemeClr val="bg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solidFill>
                      <a:srgbClr val="39B88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lacebo</a:t>
                      </a:r>
                    </a:p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=8</a:t>
                      </a:r>
                    </a:p>
                  </a:txBody>
                  <a:tcPr>
                    <a:solidFill>
                      <a:srgbClr val="39B88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5 mg/kg cidofovir n=9</a:t>
                      </a:r>
                    </a:p>
                  </a:txBody>
                  <a:tcPr>
                    <a:solidFill>
                      <a:srgbClr val="39B88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5 mg/kg cidofovir n=5</a:t>
                      </a:r>
                    </a:p>
                  </a:txBody>
                  <a:tcPr>
                    <a:solidFill>
                      <a:srgbClr val="39B88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967517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4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&gt;1 log</a:t>
                      </a:r>
                      <a:r>
                        <a:rPr lang="en-US" sz="1400" baseline="-250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</a:t>
                      </a:r>
                      <a:r>
                        <a:rPr lang="en-US" sz="14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reduction in plasma </a:t>
                      </a:r>
                      <a:r>
                        <a:rPr lang="en-US" sz="1400" dirty="0" err="1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BKPyV</a:t>
                      </a:r>
                      <a:r>
                        <a:rPr lang="en-US" sz="14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loa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 (25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 (22.2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 (20%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1688071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Change in log</a:t>
                      </a:r>
                      <a:r>
                        <a:rPr lang="en-US" sz="1400" kern="1200" baseline="-250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10</a:t>
                      </a: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 plasma </a:t>
                      </a:r>
                      <a:r>
                        <a:rPr lang="en-US" sz="1400" kern="120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BKPyV</a:t>
                      </a: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 load from day 0 to 49, median (range)</a:t>
                      </a: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US" sz="14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-0.5</a:t>
                      </a:r>
                    </a:p>
                    <a:p>
                      <a:pPr algn="ctr"/>
                      <a:r>
                        <a:rPr lang="en-US" sz="1600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(-1.6 – 1.1)</a:t>
                      </a:r>
                      <a:r>
                        <a:rPr lang="en-US" sz="16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US" sz="16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0.4 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-1.4 - 0.1)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0.6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-1.1 - -0.1)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02964854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4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ny adverse even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6 (75%)</a:t>
                      </a:r>
                      <a:r>
                        <a:rPr lang="en-US" sz="16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US" sz="16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 (66.7%)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 (60%)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117304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ncrease in creatinine by ≥20% of baseline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 (37.5%)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 (33.3%)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 (20%)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1137454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80512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B32E07EFAD3E54C82B0ADD6F67780BC" ma:contentTypeVersion="12" ma:contentTypeDescription="Create a new document." ma:contentTypeScope="" ma:versionID="ae816242d01d668c2db721fa9edcdf46">
  <xsd:schema xmlns:xsd="http://www.w3.org/2001/XMLSchema" xmlns:xs="http://www.w3.org/2001/XMLSchema" xmlns:p="http://schemas.microsoft.com/office/2006/metadata/properties" xmlns:ns3="4748f3cc-a7b3-4f74-9c2f-91806ac88731" xmlns:ns4="a50305bf-f20c-45b5-95fe-0c3b9f2af3a3" targetNamespace="http://schemas.microsoft.com/office/2006/metadata/properties" ma:root="true" ma:fieldsID="8ca5950ea94b62bb1bf2a602428f57fa" ns3:_="" ns4:_="">
    <xsd:import namespace="4748f3cc-a7b3-4f74-9c2f-91806ac88731"/>
    <xsd:import namespace="a50305bf-f20c-45b5-95fe-0c3b9f2af3a3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748f3cc-a7b3-4f74-9c2f-91806ac8873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50305bf-f20c-45b5-95fe-0c3b9f2af3a3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952490DB-A17C-4E96-B3C6-7A6120172BC3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7E85C07C-ED92-468F-ADCD-68FCA18E72E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748f3cc-a7b3-4f74-9c2f-91806ac88731"/>
    <ds:schemaRef ds:uri="a50305bf-f20c-45b5-95fe-0c3b9f2af3a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A7FC2848-6B7E-4378-81B4-50ED554E686C}">
  <ds:schemaRefs>
    <ds:schemaRef ds:uri="http://purl.org/dc/dcmitype/"/>
    <ds:schemaRef ds:uri="http://schemas.openxmlformats.org/package/2006/metadata/core-properties"/>
    <ds:schemaRef ds:uri="4748f3cc-a7b3-4f74-9c2f-91806ac88731"/>
    <ds:schemaRef ds:uri="http://schemas.microsoft.com/office/2006/documentManagement/types"/>
    <ds:schemaRef ds:uri="http://purl.org/dc/terms/"/>
    <ds:schemaRef ds:uri="a50305bf-f20c-45b5-95fe-0c3b9f2af3a3"/>
    <ds:schemaRef ds:uri="http://schemas.microsoft.com/office/infopath/2007/PartnerControls"/>
    <ds:schemaRef ds:uri="http://schemas.microsoft.com/office/2006/metadata/properties"/>
    <ds:schemaRef ds:uri="http://www.w3.org/XML/1998/namespace"/>
    <ds:schemaRef ds:uri="http://purl.org/dc/elements/1.1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691</TotalTime>
  <Words>262</Words>
  <Application>Microsoft Macintosh PowerPoint</Application>
  <PresentationFormat>Widescreen</PresentationFormat>
  <Paragraphs>4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G Ison</dc:creator>
  <cp:lastModifiedBy>Hannah N. Imlay</cp:lastModifiedBy>
  <cp:revision>19</cp:revision>
  <dcterms:created xsi:type="dcterms:W3CDTF">2021-10-22T20:34:26Z</dcterms:created>
  <dcterms:modified xsi:type="dcterms:W3CDTF">2024-07-29T17:01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B32E07EFAD3E54C82B0ADD6F67780BC</vt:lpwstr>
  </property>
</Properties>
</file>